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47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/>
      <c:overlay val="0"/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J$2:$J$7</c:f>
              <c:numCache>
                <c:formatCode>General</c:formatCode>
                <c:ptCount val="6"/>
                <c:pt idx="0">
                  <c:v>9.9078341013824893</c:v>
                </c:pt>
                <c:pt idx="1">
                  <c:v>30.184331797235025</c:v>
                </c:pt>
                <c:pt idx="2">
                  <c:v>8.2949308755760374</c:v>
                </c:pt>
                <c:pt idx="3">
                  <c:v>27.880184331797189</c:v>
                </c:pt>
                <c:pt idx="4">
                  <c:v>4.3778801843317972</c:v>
                </c:pt>
                <c:pt idx="5">
                  <c:v>19.35483870967754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K$2:$K$7</c:f>
              <c:numCache>
                <c:formatCode>General</c:formatCode>
                <c:ptCount val="6"/>
                <c:pt idx="0">
                  <c:v>8.2687338501292267</c:v>
                </c:pt>
                <c:pt idx="1">
                  <c:v>26.098191214470283</c:v>
                </c:pt>
                <c:pt idx="2">
                  <c:v>14.470284237726174</c:v>
                </c:pt>
                <c:pt idx="3">
                  <c:v>12.919896640826872</c:v>
                </c:pt>
                <c:pt idx="4">
                  <c:v>7.7519379844961334</c:v>
                </c:pt>
                <c:pt idx="5">
                  <c:v>30.490956072351423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L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L$2:$L$7</c:f>
              <c:numCache>
                <c:formatCode>General</c:formatCode>
                <c:ptCount val="6"/>
                <c:pt idx="0">
                  <c:v>8.7378640776699026</c:v>
                </c:pt>
                <c:pt idx="1">
                  <c:v>23.543689320388289</c:v>
                </c:pt>
                <c:pt idx="2">
                  <c:v>10.92233009708743</c:v>
                </c:pt>
                <c:pt idx="3">
                  <c:v>34.466019417475763</c:v>
                </c:pt>
                <c:pt idx="4">
                  <c:v>7.7669902912621414</c:v>
                </c:pt>
                <c:pt idx="5">
                  <c:v>14.563106796116504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M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M$2:$M$7</c:f>
              <c:numCache>
                <c:formatCode>General</c:formatCode>
                <c:ptCount val="6"/>
                <c:pt idx="0">
                  <c:v>14.85148514851485</c:v>
                </c:pt>
                <c:pt idx="1">
                  <c:v>21.03960396039604</c:v>
                </c:pt>
                <c:pt idx="2">
                  <c:v>25</c:v>
                </c:pt>
                <c:pt idx="3">
                  <c:v>20.792079207920654</c:v>
                </c:pt>
                <c:pt idx="4">
                  <c:v>6.4356435643564414</c:v>
                </c:pt>
                <c:pt idx="5">
                  <c:v>11.88118811881188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2632144"/>
        <c:axId val="507443784"/>
      </c:scatterChart>
      <c:valAx>
        <c:axId val="412632144"/>
        <c:scaling>
          <c:orientation val="minMax"/>
          <c:max val="6"/>
          <c:min val="0"/>
        </c:scaling>
        <c:delete val="0"/>
        <c:axPos val="b"/>
        <c:majorGridlines/>
        <c:numFmt formatCode="General" sourceLinked="1"/>
        <c:majorTickMark val="none"/>
        <c:minorTickMark val="none"/>
        <c:tickLblPos val="none"/>
        <c:spPr>
          <a:ln/>
        </c:spPr>
        <c:crossAx val="507443784"/>
        <c:crosses val="autoZero"/>
        <c:crossBetween val="midCat"/>
        <c:majorUnit val="1"/>
        <c:minorUnit val="0.4"/>
      </c:valAx>
      <c:valAx>
        <c:axId val="507443784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none"/>
        <c:minorTickMark val="none"/>
        <c:tickLblPos val="nextTo"/>
        <c:crossAx val="412632144"/>
        <c:crosses val="autoZero"/>
        <c:crossBetween val="midCat"/>
        <c:majorUnit val="20"/>
        <c:minorUnit val="1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B$2:$B$7</c:f>
              <c:numCache>
                <c:formatCode>0.00</c:formatCode>
                <c:ptCount val="6"/>
                <c:pt idx="0">
                  <c:v>5.1056338028168975</c:v>
                </c:pt>
                <c:pt idx="1">
                  <c:v>34.330985915492946</c:v>
                </c:pt>
                <c:pt idx="2">
                  <c:v>7.922535211267574</c:v>
                </c:pt>
                <c:pt idx="3">
                  <c:v>25.176056338028168</c:v>
                </c:pt>
                <c:pt idx="4">
                  <c:v>3.3450704225352008</c:v>
                </c:pt>
                <c:pt idx="5">
                  <c:v>24.11971830985919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C$2:$C$7</c:f>
              <c:numCache>
                <c:formatCode>0.00</c:formatCode>
                <c:ptCount val="6"/>
                <c:pt idx="0">
                  <c:v>4.2296072507552855</c:v>
                </c:pt>
                <c:pt idx="1">
                  <c:v>59.516616314199403</c:v>
                </c:pt>
                <c:pt idx="2">
                  <c:v>6.948640483383735</c:v>
                </c:pt>
                <c:pt idx="3">
                  <c:v>24.169184290030213</c:v>
                </c:pt>
                <c:pt idx="4">
                  <c:v>4.8338368580060145</c:v>
                </c:pt>
                <c:pt idx="5">
                  <c:v>0.30211480362537924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D$2:$D$7</c:f>
              <c:numCache>
                <c:formatCode>0.00</c:formatCode>
                <c:ptCount val="6"/>
                <c:pt idx="0">
                  <c:v>4.5936395759717312</c:v>
                </c:pt>
                <c:pt idx="1">
                  <c:v>53.710247349823327</c:v>
                </c:pt>
                <c:pt idx="2">
                  <c:v>13.780918727915132</c:v>
                </c:pt>
                <c:pt idx="3">
                  <c:v>18.374558303887014</c:v>
                </c:pt>
                <c:pt idx="4">
                  <c:v>7.7738515901060072</c:v>
                </c:pt>
                <c:pt idx="5">
                  <c:v>1.766784452296819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E$2:$E$7</c:f>
              <c:numCache>
                <c:formatCode>0.00</c:formatCode>
                <c:ptCount val="6"/>
                <c:pt idx="0">
                  <c:v>4.4052863436123424</c:v>
                </c:pt>
                <c:pt idx="1">
                  <c:v>55.726872246696033</c:v>
                </c:pt>
                <c:pt idx="2">
                  <c:v>7.0484581497797363</c:v>
                </c:pt>
                <c:pt idx="3">
                  <c:v>16.740088105726873</c:v>
                </c:pt>
                <c:pt idx="4">
                  <c:v>1.7621145374449338</c:v>
                </c:pt>
                <c:pt idx="5">
                  <c:v>14.31718061674012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7444568"/>
        <c:axId val="507444960"/>
      </c:scatterChart>
      <c:valAx>
        <c:axId val="507444568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507444960"/>
        <c:crosses val="autoZero"/>
        <c:crossBetween val="midCat"/>
        <c:majorUnit val="1"/>
        <c:minorUnit val="0.4"/>
      </c:valAx>
      <c:valAx>
        <c:axId val="507444960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507444568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B$8:$B$13</c:f>
              <c:numCache>
                <c:formatCode>0.00</c:formatCode>
                <c:ptCount val="6"/>
                <c:pt idx="0">
                  <c:v>17.621145374449327</c:v>
                </c:pt>
                <c:pt idx="1">
                  <c:v>10.13215859030837</c:v>
                </c:pt>
                <c:pt idx="2">
                  <c:v>0.44052863436123352</c:v>
                </c:pt>
                <c:pt idx="3">
                  <c:v>70.925110132158039</c:v>
                </c:pt>
                <c:pt idx="4">
                  <c:v>0.88105726872246326</c:v>
                </c:pt>
                <c:pt idx="5">
                  <c:v>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C$8:$C$13</c:f>
              <c:numCache>
                <c:formatCode>0.00</c:formatCode>
                <c:ptCount val="6"/>
                <c:pt idx="0">
                  <c:v>3.6789297658862892</c:v>
                </c:pt>
                <c:pt idx="1">
                  <c:v>42.140468227424762</c:v>
                </c:pt>
                <c:pt idx="2">
                  <c:v>4.3478260869565215</c:v>
                </c:pt>
                <c:pt idx="3">
                  <c:v>43.143812709030101</c:v>
                </c:pt>
                <c:pt idx="4">
                  <c:v>1.0033444816053512</c:v>
                </c:pt>
                <c:pt idx="5">
                  <c:v>5.685618729096975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D$8:$D$13</c:f>
              <c:numCache>
                <c:formatCode>0.00</c:formatCode>
                <c:ptCount val="6"/>
                <c:pt idx="0">
                  <c:v>2.3255813953488373</c:v>
                </c:pt>
                <c:pt idx="1">
                  <c:v>42.857142857142591</c:v>
                </c:pt>
                <c:pt idx="2">
                  <c:v>6.9767441860465134</c:v>
                </c:pt>
                <c:pt idx="3">
                  <c:v>40.863787375415122</c:v>
                </c:pt>
                <c:pt idx="4">
                  <c:v>2.3255813953488373</c:v>
                </c:pt>
                <c:pt idx="5">
                  <c:v>4.651162790697693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E$8:$E$13</c:f>
              <c:numCache>
                <c:formatCode>0.00</c:formatCode>
                <c:ptCount val="6"/>
                <c:pt idx="0">
                  <c:v>7.608695652173914</c:v>
                </c:pt>
                <c:pt idx="1">
                  <c:v>29.782608695652176</c:v>
                </c:pt>
                <c:pt idx="2">
                  <c:v>24.130434782608695</c:v>
                </c:pt>
                <c:pt idx="3">
                  <c:v>34.347826086956239</c:v>
                </c:pt>
                <c:pt idx="4">
                  <c:v>1.3043478260869643</c:v>
                </c:pt>
                <c:pt idx="5">
                  <c:v>2.826086956521738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7390536"/>
        <c:axId val="507390928"/>
      </c:scatterChart>
      <c:valAx>
        <c:axId val="507390536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507390928"/>
        <c:crosses val="autoZero"/>
        <c:crossBetween val="midCat"/>
        <c:majorUnit val="1"/>
        <c:minorUnit val="0.4"/>
      </c:valAx>
      <c:valAx>
        <c:axId val="507390928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507390536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B$14:$B$19</c:f>
              <c:numCache>
                <c:formatCode>0.00</c:formatCode>
                <c:ptCount val="6"/>
                <c:pt idx="0">
                  <c:v>17.431192660550458</c:v>
                </c:pt>
                <c:pt idx="1">
                  <c:v>6.4220183486238485</c:v>
                </c:pt>
                <c:pt idx="2">
                  <c:v>1.834862385321101</c:v>
                </c:pt>
                <c:pt idx="3">
                  <c:v>59.633027522935812</c:v>
                </c:pt>
                <c:pt idx="4">
                  <c:v>14.678899082568808</c:v>
                </c:pt>
                <c:pt idx="5">
                  <c:v>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C$14:$C$19</c:f>
              <c:numCache>
                <c:formatCode>0.00</c:formatCode>
                <c:ptCount val="6"/>
                <c:pt idx="0">
                  <c:v>2.8368794326240923</c:v>
                </c:pt>
                <c:pt idx="1">
                  <c:v>9.5744680851063837</c:v>
                </c:pt>
                <c:pt idx="2">
                  <c:v>12.76595744680851</c:v>
                </c:pt>
                <c:pt idx="3">
                  <c:v>71.276595744680819</c:v>
                </c:pt>
                <c:pt idx="4">
                  <c:v>0.70921985815602862</c:v>
                </c:pt>
                <c:pt idx="5">
                  <c:v>0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D$14:$D$19</c:f>
              <c:numCache>
                <c:formatCode>0.00</c:formatCode>
                <c:ptCount val="6"/>
                <c:pt idx="0">
                  <c:v>4.4897959183673484</c:v>
                </c:pt>
                <c:pt idx="1">
                  <c:v>21.224489795918366</c:v>
                </c:pt>
                <c:pt idx="2">
                  <c:v>2.0408163265306132</c:v>
                </c:pt>
                <c:pt idx="3">
                  <c:v>68.16326530612244</c:v>
                </c:pt>
                <c:pt idx="4">
                  <c:v>4.0816326530612423</c:v>
                </c:pt>
                <c:pt idx="5">
                  <c:v>0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E$14:$E$19</c:f>
              <c:numCache>
                <c:formatCode>0.00</c:formatCode>
                <c:ptCount val="6"/>
                <c:pt idx="0">
                  <c:v>8.2417582417582409</c:v>
                </c:pt>
                <c:pt idx="1">
                  <c:v>24.175824175824175</c:v>
                </c:pt>
                <c:pt idx="2">
                  <c:v>15.659340659340707</c:v>
                </c:pt>
                <c:pt idx="3">
                  <c:v>48.626373626373663</c:v>
                </c:pt>
                <c:pt idx="4">
                  <c:v>3.296703296703297</c:v>
                </c:pt>
                <c:pt idx="5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7391712"/>
        <c:axId val="507392104"/>
      </c:scatterChart>
      <c:valAx>
        <c:axId val="507391712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507392104"/>
        <c:crosses val="autoZero"/>
        <c:crossBetween val="midCat"/>
        <c:majorUnit val="1"/>
        <c:minorUnit val="0.4"/>
      </c:valAx>
      <c:valAx>
        <c:axId val="507392104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507391712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B$20:$B$25</c:f>
              <c:numCache>
                <c:formatCode>0.00</c:formatCode>
                <c:ptCount val="6"/>
                <c:pt idx="0">
                  <c:v>17.469879518072286</c:v>
                </c:pt>
                <c:pt idx="1">
                  <c:v>8.0321285140562253</c:v>
                </c:pt>
                <c:pt idx="2">
                  <c:v>3.6144578313253009</c:v>
                </c:pt>
                <c:pt idx="3">
                  <c:v>64.056224899598391</c:v>
                </c:pt>
                <c:pt idx="4">
                  <c:v>6.8273092369477606</c:v>
                </c:pt>
                <c:pt idx="5">
                  <c:v>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C$20:$C$25</c:f>
              <c:numCache>
                <c:formatCode>0.00</c:formatCode>
                <c:ptCount val="6"/>
                <c:pt idx="0">
                  <c:v>6.2827225130890074</c:v>
                </c:pt>
                <c:pt idx="1">
                  <c:v>11.518324607329843</c:v>
                </c:pt>
                <c:pt idx="2">
                  <c:v>15.183246073298429</c:v>
                </c:pt>
                <c:pt idx="3">
                  <c:v>64.659685863874259</c:v>
                </c:pt>
                <c:pt idx="4">
                  <c:v>0.78534031413612571</c:v>
                </c:pt>
                <c:pt idx="5">
                  <c:v>0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D$20:$D$25</c:f>
              <c:numCache>
                <c:formatCode>0.00</c:formatCode>
                <c:ptCount val="6"/>
                <c:pt idx="0">
                  <c:v>6.3339731285988483</c:v>
                </c:pt>
                <c:pt idx="1">
                  <c:v>13.819577735124772</c:v>
                </c:pt>
                <c:pt idx="2">
                  <c:v>19.577735124760075</c:v>
                </c:pt>
                <c:pt idx="3">
                  <c:v>60.076775431861812</c:v>
                </c:pt>
                <c:pt idx="4">
                  <c:v>0.19193857965451017</c:v>
                </c:pt>
                <c:pt idx="5">
                  <c:v>0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E$20:$E$25</c:f>
              <c:numCache>
                <c:formatCode>0.00</c:formatCode>
                <c:ptCount val="6"/>
                <c:pt idx="0">
                  <c:v>0.90293453724604955</c:v>
                </c:pt>
                <c:pt idx="1">
                  <c:v>8.5778781038374419</c:v>
                </c:pt>
                <c:pt idx="2">
                  <c:v>0.22573363431151239</c:v>
                </c:pt>
                <c:pt idx="3">
                  <c:v>90.293453724604973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121520"/>
        <c:axId val="373121912"/>
      </c:scatterChart>
      <c:valAx>
        <c:axId val="373121520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373121912"/>
        <c:crosses val="autoZero"/>
        <c:crossBetween val="midCat"/>
        <c:majorUnit val="1"/>
        <c:minorUnit val="0.4"/>
      </c:valAx>
      <c:valAx>
        <c:axId val="373121912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373121520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J$20:$J$25</c:f>
              <c:numCache>
                <c:formatCode>General</c:formatCode>
                <c:ptCount val="6"/>
                <c:pt idx="0">
                  <c:v>2.6570048309178742</c:v>
                </c:pt>
                <c:pt idx="1">
                  <c:v>47.101449275361986</c:v>
                </c:pt>
                <c:pt idx="2">
                  <c:v>1.4492753623188406</c:v>
                </c:pt>
                <c:pt idx="3">
                  <c:v>33.574879227053124</c:v>
                </c:pt>
                <c:pt idx="4">
                  <c:v>5.7971014492753605</c:v>
                </c:pt>
                <c:pt idx="5">
                  <c:v>9.4202898550724647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K$20:$K$25</c:f>
              <c:numCache>
                <c:formatCode>General</c:formatCode>
                <c:ptCount val="6"/>
                <c:pt idx="0">
                  <c:v>2.9213483146067367</c:v>
                </c:pt>
                <c:pt idx="1">
                  <c:v>44.943820224719097</c:v>
                </c:pt>
                <c:pt idx="2">
                  <c:v>1.7977528089887698</c:v>
                </c:pt>
                <c:pt idx="3">
                  <c:v>44.044943820224717</c:v>
                </c:pt>
                <c:pt idx="4">
                  <c:v>1.7977528089887698</c:v>
                </c:pt>
                <c:pt idx="5">
                  <c:v>4.494382022471909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L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L$20:$L$25</c:f>
              <c:numCache>
                <c:formatCode>General</c:formatCode>
                <c:ptCount val="6"/>
                <c:pt idx="0">
                  <c:v>1.0660980810234542</c:v>
                </c:pt>
                <c:pt idx="1">
                  <c:v>41.577825159914454</c:v>
                </c:pt>
                <c:pt idx="2">
                  <c:v>1.2793176972281393</c:v>
                </c:pt>
                <c:pt idx="3">
                  <c:v>46.69509594882765</c:v>
                </c:pt>
                <c:pt idx="4">
                  <c:v>1.0660980810234542</c:v>
                </c:pt>
                <c:pt idx="5">
                  <c:v>8.315565031983005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M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20:$A$25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M$20:$M$25</c:f>
              <c:numCache>
                <c:formatCode>General</c:formatCode>
                <c:ptCount val="6"/>
                <c:pt idx="0">
                  <c:v>1.4678899082568808</c:v>
                </c:pt>
                <c:pt idx="1">
                  <c:v>42.385321100917395</c:v>
                </c:pt>
                <c:pt idx="2">
                  <c:v>3.8532110091743119</c:v>
                </c:pt>
                <c:pt idx="3">
                  <c:v>40</c:v>
                </c:pt>
                <c:pt idx="4">
                  <c:v>0.18348623853211177</c:v>
                </c:pt>
                <c:pt idx="5">
                  <c:v>12.11009174311926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122696"/>
        <c:axId val="408055560"/>
      </c:scatterChart>
      <c:valAx>
        <c:axId val="373122696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408055560"/>
        <c:crosses val="autoZero"/>
        <c:crossBetween val="midCat"/>
        <c:majorUnit val="1"/>
        <c:minorUnit val="0.4"/>
      </c:valAx>
      <c:valAx>
        <c:axId val="408055560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373122696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J$14:$J$19</c:f>
              <c:numCache>
                <c:formatCode>General</c:formatCode>
                <c:ptCount val="6"/>
                <c:pt idx="0">
                  <c:v>2.0044543429844217</c:v>
                </c:pt>
                <c:pt idx="1">
                  <c:v>41.202672605790646</c:v>
                </c:pt>
                <c:pt idx="2">
                  <c:v>4.6770601336302899</c:v>
                </c:pt>
                <c:pt idx="3">
                  <c:v>33.4075723830735</c:v>
                </c:pt>
                <c:pt idx="4">
                  <c:v>7.3496659242761906</c:v>
                </c:pt>
                <c:pt idx="5">
                  <c:v>11.35857461024504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K$14:$K$19</c:f>
              <c:numCache>
                <c:formatCode>General</c:formatCode>
                <c:ptCount val="6"/>
                <c:pt idx="0">
                  <c:v>2.1226415094339623</c:v>
                </c:pt>
                <c:pt idx="1">
                  <c:v>26.17924528301889</c:v>
                </c:pt>
                <c:pt idx="2">
                  <c:v>6.1320754716981085</c:v>
                </c:pt>
                <c:pt idx="3">
                  <c:v>56.60377358490566</c:v>
                </c:pt>
                <c:pt idx="4">
                  <c:v>3.0660377358490591</c:v>
                </c:pt>
                <c:pt idx="5">
                  <c:v>5.896226415094377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L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L$14:$L$19</c:f>
              <c:numCache>
                <c:formatCode>General</c:formatCode>
                <c:ptCount val="6"/>
                <c:pt idx="0">
                  <c:v>1.48619957537155</c:v>
                </c:pt>
                <c:pt idx="1">
                  <c:v>31.422505307855626</c:v>
                </c:pt>
                <c:pt idx="2">
                  <c:v>2.7600849256900215</c:v>
                </c:pt>
                <c:pt idx="3">
                  <c:v>54.140127388535063</c:v>
                </c:pt>
                <c:pt idx="4">
                  <c:v>5.5201698513800395</c:v>
                </c:pt>
                <c:pt idx="5">
                  <c:v>4.6709129511677245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M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14:$A$19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M$14:$M$19</c:f>
              <c:numCache>
                <c:formatCode>General</c:formatCode>
                <c:ptCount val="6"/>
                <c:pt idx="0">
                  <c:v>0.95465393794749465</c:v>
                </c:pt>
                <c:pt idx="1">
                  <c:v>30.310262529832936</c:v>
                </c:pt>
                <c:pt idx="2">
                  <c:v>9.3078758949880704</c:v>
                </c:pt>
                <c:pt idx="3">
                  <c:v>42.720763723150363</c:v>
                </c:pt>
                <c:pt idx="4">
                  <c:v>9.3078758949880704</c:v>
                </c:pt>
                <c:pt idx="5">
                  <c:v>7.398568019093078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8056344"/>
        <c:axId val="408056736"/>
      </c:scatterChart>
      <c:valAx>
        <c:axId val="408056344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408056736"/>
        <c:crosses val="autoZero"/>
        <c:crossBetween val="midCat"/>
        <c:majorUnit val="1"/>
        <c:minorUnit val="0.4"/>
      </c:valAx>
      <c:valAx>
        <c:axId val="408056736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408056344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J$8:$J$13</c:f>
              <c:numCache>
                <c:formatCode>General</c:formatCode>
                <c:ptCount val="6"/>
                <c:pt idx="0">
                  <c:v>3.4722222222222223</c:v>
                </c:pt>
                <c:pt idx="1">
                  <c:v>43.055555555555557</c:v>
                </c:pt>
                <c:pt idx="2">
                  <c:v>5.0925925925925926</c:v>
                </c:pt>
                <c:pt idx="3">
                  <c:v>20.370370370370289</c:v>
                </c:pt>
                <c:pt idx="4">
                  <c:v>15.046296296296306</c:v>
                </c:pt>
                <c:pt idx="5">
                  <c:v>12.96296296296297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K$8:$K$13</c:f>
              <c:numCache>
                <c:formatCode>General</c:formatCode>
                <c:ptCount val="6"/>
                <c:pt idx="0">
                  <c:v>2.1008403361344539</c:v>
                </c:pt>
                <c:pt idx="1">
                  <c:v>37.184873949580009</c:v>
                </c:pt>
                <c:pt idx="2">
                  <c:v>13.865546218487541</c:v>
                </c:pt>
                <c:pt idx="3">
                  <c:v>26.050420168067227</c:v>
                </c:pt>
                <c:pt idx="4">
                  <c:v>13.23529411764707</c:v>
                </c:pt>
                <c:pt idx="5">
                  <c:v>7.563025210084032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L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L$8:$L$13</c:f>
              <c:numCache>
                <c:formatCode>General</c:formatCode>
                <c:ptCount val="6"/>
                <c:pt idx="0">
                  <c:v>2.810304449648712</c:v>
                </c:pt>
                <c:pt idx="1">
                  <c:v>38.407494145199045</c:v>
                </c:pt>
                <c:pt idx="2">
                  <c:v>9.1334894613583142</c:v>
                </c:pt>
                <c:pt idx="3">
                  <c:v>20.608899297423889</c:v>
                </c:pt>
                <c:pt idx="4">
                  <c:v>16.393442622950786</c:v>
                </c:pt>
                <c:pt idx="5">
                  <c:v>12.64637002341914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M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8:$A$13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M$8:$M$13</c:f>
              <c:numCache>
                <c:formatCode>General</c:formatCode>
                <c:ptCount val="6"/>
                <c:pt idx="0">
                  <c:v>2.1844660194174756</c:v>
                </c:pt>
                <c:pt idx="1">
                  <c:v>30.825242718446599</c:v>
                </c:pt>
                <c:pt idx="2">
                  <c:v>13.106796116504874</c:v>
                </c:pt>
                <c:pt idx="3">
                  <c:v>36.650485436893028</c:v>
                </c:pt>
                <c:pt idx="4">
                  <c:v>9.4660194174757297</c:v>
                </c:pt>
                <c:pt idx="5">
                  <c:v>7.766990291262141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8057520"/>
        <c:axId val="408057912"/>
      </c:scatterChart>
      <c:valAx>
        <c:axId val="408057520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408057912"/>
        <c:crosses val="autoZero"/>
        <c:crossBetween val="midCat"/>
        <c:majorUnit val="1"/>
        <c:minorUnit val="0.4"/>
      </c:valAx>
      <c:valAx>
        <c:axId val="408057912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408057520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DMEMF12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J$2:$J$7</c:f>
              <c:numCache>
                <c:formatCode>General</c:formatCode>
                <c:ptCount val="6"/>
                <c:pt idx="0">
                  <c:v>9.9078341013824893</c:v>
                </c:pt>
                <c:pt idx="1">
                  <c:v>30.184331797235025</c:v>
                </c:pt>
                <c:pt idx="2">
                  <c:v>8.2949308755760374</c:v>
                </c:pt>
                <c:pt idx="3">
                  <c:v>27.880184331797189</c:v>
                </c:pt>
                <c:pt idx="4">
                  <c:v>4.3778801843317972</c:v>
                </c:pt>
                <c:pt idx="5">
                  <c:v>19.35483870967754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K$1</c:f>
              <c:strCache>
                <c:ptCount val="1"/>
                <c:pt idx="0">
                  <c:v>DMEM Low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K$2:$K$7</c:f>
              <c:numCache>
                <c:formatCode>General</c:formatCode>
                <c:ptCount val="6"/>
                <c:pt idx="0">
                  <c:v>8.2687338501292267</c:v>
                </c:pt>
                <c:pt idx="1">
                  <c:v>26.098191214470283</c:v>
                </c:pt>
                <c:pt idx="2">
                  <c:v>14.470284237726174</c:v>
                </c:pt>
                <c:pt idx="3">
                  <c:v>12.919896640826872</c:v>
                </c:pt>
                <c:pt idx="4">
                  <c:v>7.7519379844961334</c:v>
                </c:pt>
                <c:pt idx="5">
                  <c:v>30.490956072351423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L$1</c:f>
              <c:strCache>
                <c:ptCount val="1"/>
                <c:pt idx="0">
                  <c:v>DMEM High glucose 10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L$2:$L$7</c:f>
              <c:numCache>
                <c:formatCode>General</c:formatCode>
                <c:ptCount val="6"/>
                <c:pt idx="0">
                  <c:v>8.7378640776699026</c:v>
                </c:pt>
                <c:pt idx="1">
                  <c:v>23.543689320388289</c:v>
                </c:pt>
                <c:pt idx="2">
                  <c:v>10.92233009708743</c:v>
                </c:pt>
                <c:pt idx="3">
                  <c:v>34.466019417475763</c:v>
                </c:pt>
                <c:pt idx="4">
                  <c:v>7.7669902912621414</c:v>
                </c:pt>
                <c:pt idx="5">
                  <c:v>14.563106796116504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M$1</c:f>
              <c:strCache>
                <c:ptCount val="1"/>
                <c:pt idx="0">
                  <c:v>DMEM High glucose 5% FBS</c:v>
                </c:pt>
              </c:strCache>
            </c:strRef>
          </c:tx>
          <c:xVal>
            <c:strRef>
              <c:f>Sheet1!$A$2:$A$7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</c:strCache>
            </c:strRef>
          </c:xVal>
          <c:yVal>
            <c:numRef>
              <c:f>Sheet1!$M$2:$M$7</c:f>
              <c:numCache>
                <c:formatCode>General</c:formatCode>
                <c:ptCount val="6"/>
                <c:pt idx="0">
                  <c:v>14.85148514851485</c:v>
                </c:pt>
                <c:pt idx="1">
                  <c:v>21.03960396039604</c:v>
                </c:pt>
                <c:pt idx="2">
                  <c:v>25</c:v>
                </c:pt>
                <c:pt idx="3">
                  <c:v>20.792079207920654</c:v>
                </c:pt>
                <c:pt idx="4">
                  <c:v>6.4356435643564414</c:v>
                </c:pt>
                <c:pt idx="5">
                  <c:v>11.88118811881188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8058696"/>
        <c:axId val="408059088"/>
      </c:scatterChart>
      <c:valAx>
        <c:axId val="408058696"/>
        <c:scaling>
          <c:orientation val="minMax"/>
          <c:max val="6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/>
        </c:spPr>
        <c:crossAx val="408059088"/>
        <c:crosses val="autoZero"/>
        <c:crossBetween val="midCat"/>
        <c:majorUnit val="1"/>
        <c:minorUnit val="0.4"/>
      </c:valAx>
      <c:valAx>
        <c:axId val="408059088"/>
        <c:scaling>
          <c:orientation val="minMax"/>
          <c:max val="100"/>
          <c:min val="0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408058696"/>
        <c:crosses val="autoZero"/>
        <c:crossBetween val="midCat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4A453-AA48-49A4-B4DF-355B6751542E}" type="datetimeFigureOut">
              <a:rPr lang="en-US" smtClean="0"/>
              <a:t>5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08AB2-BD2C-48D3-839A-7F41DBFC6E2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76200" y="1143000"/>
            <a:ext cx="6675437" cy="6934200"/>
            <a:chOff x="76200" y="1143000"/>
            <a:chExt cx="6675437" cy="6934200"/>
          </a:xfrm>
        </p:grpSpPr>
        <p:grpSp>
          <p:nvGrpSpPr>
            <p:cNvPr id="5" name="Group 4"/>
            <p:cNvGrpSpPr>
              <a:grpSpLocks/>
            </p:cNvGrpSpPr>
            <p:nvPr/>
          </p:nvGrpSpPr>
          <p:grpSpPr bwMode="auto">
            <a:xfrm>
              <a:off x="76200" y="5226050"/>
              <a:ext cx="6675437" cy="2851150"/>
              <a:chOff x="-4735330" y="9523390"/>
              <a:chExt cx="8394932" cy="2851123"/>
            </a:xfrm>
          </p:grpSpPr>
          <p:graphicFrame>
            <p:nvGraphicFramePr>
              <p:cNvPr id="39" name="Chart 38"/>
              <p:cNvGraphicFramePr>
                <a:graphicFrameLocks/>
              </p:cNvGraphicFramePr>
              <p:nvPr/>
            </p:nvGraphicFramePr>
            <p:xfrm>
              <a:off x="-4042005" y="9626713"/>
              <a:ext cx="7551968" cy="2747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0" name="Rectangle 39"/>
              <p:cNvSpPr/>
              <p:nvPr/>
            </p:nvSpPr>
            <p:spPr bwMode="auto">
              <a:xfrm>
                <a:off x="-4735330" y="9523390"/>
                <a:ext cx="8394932" cy="23447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1371600" y="1143000"/>
              <a:ext cx="4180429" cy="6325814"/>
              <a:chOff x="1371600" y="1143000"/>
              <a:chExt cx="4180429" cy="6325814"/>
            </a:xfrm>
          </p:grpSpPr>
          <p:sp>
            <p:nvSpPr>
              <p:cNvPr id="14" name="Rectangle 23"/>
              <p:cNvSpPr>
                <a:spLocks noChangeArrowheads="1"/>
              </p:cNvSpPr>
              <p:nvPr/>
            </p:nvSpPr>
            <p:spPr bwMode="auto">
              <a:xfrm rot="16200000">
                <a:off x="1354932" y="6583176"/>
                <a:ext cx="8890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altLang="en-US" sz="10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ercentage %</a:t>
                </a:r>
              </a:p>
            </p:txBody>
          </p:sp>
          <p:sp>
            <p:nvSpPr>
              <p:cNvPr id="16" name="TextBox 55"/>
              <p:cNvSpPr txBox="1">
                <a:spLocks noChangeArrowheads="1"/>
              </p:cNvSpPr>
              <p:nvPr/>
            </p:nvSpPr>
            <p:spPr bwMode="auto">
              <a:xfrm>
                <a:off x="1371600" y="1143000"/>
                <a:ext cx="725488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dirty="0">
                    <a:latin typeface="Times New Roman" pitchFamily="18" charset="0"/>
                    <a:cs typeface="Times New Roman" pitchFamily="18" charset="0"/>
                  </a:rPr>
                  <a:t>Week 1</a:t>
                </a:r>
                <a:endParaRPr lang="en-GB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66"/>
              <p:cNvSpPr txBox="1">
                <a:spLocks noChangeArrowheads="1"/>
              </p:cNvSpPr>
              <p:nvPr/>
            </p:nvSpPr>
            <p:spPr bwMode="auto">
              <a:xfrm>
                <a:off x="1371600" y="2667000"/>
                <a:ext cx="725487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dirty="0">
                    <a:latin typeface="Times New Roman" pitchFamily="18" charset="0"/>
                    <a:cs typeface="Times New Roman" pitchFamily="18" charset="0"/>
                  </a:rPr>
                  <a:t>Week 2</a:t>
                </a:r>
                <a:endParaRPr lang="en-GB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67"/>
              <p:cNvSpPr txBox="1">
                <a:spLocks noChangeArrowheads="1"/>
              </p:cNvSpPr>
              <p:nvPr/>
            </p:nvSpPr>
            <p:spPr bwMode="auto">
              <a:xfrm>
                <a:off x="1371600" y="4191000"/>
                <a:ext cx="725487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dirty="0">
                    <a:latin typeface="Times New Roman" pitchFamily="18" charset="0"/>
                    <a:cs typeface="Times New Roman" pitchFamily="18" charset="0"/>
                  </a:rPr>
                  <a:t>Week 3</a:t>
                </a:r>
                <a:endParaRPr lang="en-GB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68"/>
              <p:cNvSpPr txBox="1">
                <a:spLocks noChangeArrowheads="1"/>
              </p:cNvSpPr>
              <p:nvPr/>
            </p:nvSpPr>
            <p:spPr bwMode="auto">
              <a:xfrm>
                <a:off x="1371600" y="5715000"/>
                <a:ext cx="725487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dirty="0">
                    <a:latin typeface="Times New Roman" pitchFamily="18" charset="0"/>
                    <a:cs typeface="Times New Roman" pitchFamily="18" charset="0"/>
                  </a:rPr>
                  <a:t>Week 4</a:t>
                </a:r>
                <a:endParaRPr lang="en-GB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Rectangle 23"/>
              <p:cNvSpPr>
                <a:spLocks noChangeArrowheads="1"/>
              </p:cNvSpPr>
              <p:nvPr/>
            </p:nvSpPr>
            <p:spPr bwMode="auto">
              <a:xfrm rot="16200000">
                <a:off x="1354931" y="2011176"/>
                <a:ext cx="8890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altLang="en-US" sz="10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ercentage %</a:t>
                </a:r>
              </a:p>
            </p:txBody>
          </p:sp>
          <p:sp>
            <p:nvSpPr>
              <p:cNvPr id="21" name="TextBox 3"/>
              <p:cNvSpPr txBox="1">
                <a:spLocks noChangeArrowheads="1"/>
              </p:cNvSpPr>
              <p:nvPr/>
            </p:nvSpPr>
            <p:spPr bwMode="auto">
              <a:xfrm>
                <a:off x="2409825" y="1169987"/>
                <a:ext cx="866775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200" dirty="0">
                    <a:latin typeface="Times New Roman" pitchFamily="18" charset="0"/>
                    <a:cs typeface="Times New Roman" pitchFamily="18" charset="0"/>
                  </a:rPr>
                  <a:t>Jed62_MN</a:t>
                </a:r>
                <a:endParaRPr lang="en-GB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80"/>
              <p:cNvSpPr txBox="1">
                <a:spLocks noChangeArrowheads="1"/>
              </p:cNvSpPr>
              <p:nvPr/>
            </p:nvSpPr>
            <p:spPr bwMode="auto">
              <a:xfrm>
                <a:off x="4313237" y="1169987"/>
                <a:ext cx="868363" cy="2778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200" dirty="0">
                    <a:latin typeface="Times New Roman" pitchFamily="18" charset="0"/>
                    <a:cs typeface="Times New Roman" pitchFamily="18" charset="0"/>
                  </a:rPr>
                  <a:t>Jed79_MN</a:t>
                </a:r>
                <a:endParaRPr lang="en-GB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48" name="Group 47"/>
              <p:cNvGrpSpPr/>
              <p:nvPr/>
            </p:nvGrpSpPr>
            <p:grpSpPr>
              <a:xfrm>
                <a:off x="1847073" y="1373795"/>
                <a:ext cx="1811068" cy="1520825"/>
                <a:chOff x="74882" y="1295400"/>
                <a:chExt cx="1811068" cy="1520825"/>
              </a:xfrm>
            </p:grpSpPr>
            <p:graphicFrame>
              <p:nvGraphicFramePr>
                <p:cNvPr id="6" name="Chart 5"/>
                <p:cNvGraphicFramePr>
                  <a:graphicFrameLocks/>
                </p:cNvGraphicFramePr>
                <p:nvPr/>
              </p:nvGraphicFramePr>
              <p:xfrm>
                <a:off x="74882" y="1295400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5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481012" y="2424113"/>
                  <a:ext cx="1404938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 dirty="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5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479425" y="2570163"/>
                  <a:ext cx="1309687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</p:grpSp>
          <p:grpSp>
            <p:nvGrpSpPr>
              <p:cNvPr id="47" name="Group 46"/>
              <p:cNvGrpSpPr/>
              <p:nvPr/>
            </p:nvGrpSpPr>
            <p:grpSpPr>
              <a:xfrm>
                <a:off x="1829341" y="2857500"/>
                <a:ext cx="1828800" cy="1520825"/>
                <a:chOff x="1700212" y="1295400"/>
                <a:chExt cx="1828800" cy="1520825"/>
              </a:xfrm>
            </p:grpSpPr>
            <p:graphicFrame>
              <p:nvGraphicFramePr>
                <p:cNvPr id="7" name="Chart 6"/>
                <p:cNvGraphicFramePr>
                  <a:graphicFrameLocks/>
                </p:cNvGraphicFramePr>
                <p:nvPr/>
              </p:nvGraphicFramePr>
              <p:xfrm>
                <a:off x="1700212" y="1295400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23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2112962" y="2570163"/>
                  <a:ext cx="1309688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1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2124075" y="2424113"/>
                  <a:ext cx="1404937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4" name="Group 43"/>
              <p:cNvGrpSpPr/>
              <p:nvPr/>
            </p:nvGrpSpPr>
            <p:grpSpPr>
              <a:xfrm>
                <a:off x="1838596" y="4421795"/>
                <a:ext cx="1819545" cy="1520825"/>
                <a:chOff x="3325542" y="1295400"/>
                <a:chExt cx="1819545" cy="1520825"/>
              </a:xfrm>
            </p:grpSpPr>
            <p:graphicFrame>
              <p:nvGraphicFramePr>
                <p:cNvPr id="8" name="Chart 7"/>
                <p:cNvGraphicFramePr>
                  <a:graphicFrameLocks/>
                </p:cNvGraphicFramePr>
                <p:nvPr/>
              </p:nvGraphicFramePr>
              <p:xfrm>
                <a:off x="3325542" y="1295400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24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3746500" y="2570163"/>
                  <a:ext cx="1309687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2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3740150" y="2424113"/>
                  <a:ext cx="1404937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2" name="Group 41"/>
              <p:cNvGrpSpPr/>
              <p:nvPr/>
            </p:nvGrpSpPr>
            <p:grpSpPr>
              <a:xfrm>
                <a:off x="1828800" y="5945795"/>
                <a:ext cx="1829341" cy="1520825"/>
                <a:chOff x="4950871" y="1295400"/>
                <a:chExt cx="1829341" cy="1520825"/>
              </a:xfrm>
            </p:grpSpPr>
            <p:graphicFrame>
              <p:nvGraphicFramePr>
                <p:cNvPr id="9" name="Chart 8"/>
                <p:cNvGraphicFramePr>
                  <a:graphicFrameLocks/>
                </p:cNvGraphicFramePr>
                <p:nvPr/>
              </p:nvGraphicFramePr>
              <p:xfrm>
                <a:off x="4950871" y="1295400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26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5380037" y="2570163"/>
                  <a:ext cx="1309688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3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5375275" y="2424113"/>
                  <a:ext cx="1404937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1" name="Group 40"/>
              <p:cNvGrpSpPr/>
              <p:nvPr/>
            </p:nvGrpSpPr>
            <p:grpSpPr>
              <a:xfrm>
                <a:off x="3733800" y="5943600"/>
                <a:ext cx="1818229" cy="1525214"/>
                <a:chOff x="4950871" y="2997574"/>
                <a:chExt cx="1818229" cy="1525214"/>
              </a:xfrm>
            </p:grpSpPr>
            <p:graphicFrame>
              <p:nvGraphicFramePr>
                <p:cNvPr id="13" name="Chart 12"/>
                <p:cNvGraphicFramePr>
                  <a:graphicFrameLocks/>
                </p:cNvGraphicFramePr>
                <p:nvPr/>
              </p:nvGraphicFramePr>
              <p:xfrm>
                <a:off x="4950871" y="2997574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30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5380037" y="4276725"/>
                  <a:ext cx="1309688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4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5365750" y="4114800"/>
                  <a:ext cx="1403350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 dirty="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3" name="Group 42"/>
              <p:cNvGrpSpPr/>
              <p:nvPr/>
            </p:nvGrpSpPr>
            <p:grpSpPr>
              <a:xfrm>
                <a:off x="3732484" y="4419600"/>
                <a:ext cx="1819545" cy="1525214"/>
                <a:chOff x="3325542" y="2997574"/>
                <a:chExt cx="1819545" cy="1525214"/>
              </a:xfrm>
            </p:grpSpPr>
            <p:graphicFrame>
              <p:nvGraphicFramePr>
                <p:cNvPr id="12" name="Chart 11"/>
                <p:cNvGraphicFramePr>
                  <a:graphicFrameLocks/>
                </p:cNvGraphicFramePr>
                <p:nvPr/>
              </p:nvGraphicFramePr>
              <p:xfrm>
                <a:off x="3325542" y="2997574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28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3746500" y="4276725"/>
                  <a:ext cx="1309687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5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3740150" y="4114800"/>
                  <a:ext cx="1404937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5" name="Group 44"/>
              <p:cNvGrpSpPr/>
              <p:nvPr/>
            </p:nvGrpSpPr>
            <p:grpSpPr>
              <a:xfrm>
                <a:off x="3723229" y="2855305"/>
                <a:ext cx="1828800" cy="1525214"/>
                <a:chOff x="1700212" y="2997574"/>
                <a:chExt cx="1828800" cy="1525214"/>
              </a:xfrm>
            </p:grpSpPr>
            <p:graphicFrame>
              <p:nvGraphicFramePr>
                <p:cNvPr id="11" name="Chart 10"/>
                <p:cNvGraphicFramePr>
                  <a:graphicFrameLocks/>
                </p:cNvGraphicFramePr>
                <p:nvPr/>
              </p:nvGraphicFramePr>
              <p:xfrm>
                <a:off x="1700212" y="2997574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27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2112962" y="4276725"/>
                  <a:ext cx="1309688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6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2124075" y="4114800"/>
                  <a:ext cx="1404937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6" name="Group 45"/>
              <p:cNvGrpSpPr/>
              <p:nvPr/>
            </p:nvGrpSpPr>
            <p:grpSpPr>
              <a:xfrm>
                <a:off x="3740961" y="1371600"/>
                <a:ext cx="1811068" cy="1525214"/>
                <a:chOff x="74882" y="2997574"/>
                <a:chExt cx="1811068" cy="1525214"/>
              </a:xfrm>
            </p:grpSpPr>
            <p:graphicFrame>
              <p:nvGraphicFramePr>
                <p:cNvPr id="10" name="Chart 9"/>
                <p:cNvGraphicFramePr>
                  <a:graphicFrameLocks/>
                </p:cNvGraphicFramePr>
                <p:nvPr/>
              </p:nvGraphicFramePr>
              <p:xfrm>
                <a:off x="74882" y="2997574"/>
                <a:ext cx="1800000" cy="129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"/>
                </a:graphicData>
              </a:graphic>
            </p:graphicFrame>
            <p:sp>
              <p:nvSpPr>
                <p:cNvPr id="29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479425" y="4276725"/>
                  <a:ext cx="1309687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>
                      <a:latin typeface="Times New Roman" pitchFamily="18" charset="0"/>
                      <a:cs typeface="Times New Roman" pitchFamily="18" charset="0"/>
                    </a:rPr>
                    <a:t>Cell morphology type</a:t>
                  </a:r>
                </a:p>
              </p:txBody>
            </p:sp>
            <p:sp>
              <p:nvSpPr>
                <p:cNvPr id="37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481012" y="4114800"/>
                  <a:ext cx="1404938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en-US" sz="1000" dirty="0">
                      <a:latin typeface="Times New Roman" pitchFamily="18" charset="0"/>
                      <a:cs typeface="Times New Roman" pitchFamily="18" charset="0"/>
                    </a:rPr>
                    <a:t> M    N   O    G    A    D</a:t>
                  </a:r>
                  <a:endParaRPr lang="en-GB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49" name="Rectangle 23"/>
              <p:cNvSpPr>
                <a:spLocks noChangeArrowheads="1"/>
              </p:cNvSpPr>
              <p:nvPr/>
            </p:nvSpPr>
            <p:spPr bwMode="auto">
              <a:xfrm rot="16200000">
                <a:off x="1354932" y="5059176"/>
                <a:ext cx="8890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altLang="en-US" sz="10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ercentage %</a:t>
                </a:r>
              </a:p>
            </p:txBody>
          </p:sp>
          <p:sp>
            <p:nvSpPr>
              <p:cNvPr id="50" name="Rectangle 23"/>
              <p:cNvSpPr>
                <a:spLocks noChangeArrowheads="1"/>
              </p:cNvSpPr>
              <p:nvPr/>
            </p:nvSpPr>
            <p:spPr bwMode="auto">
              <a:xfrm rot="16200000">
                <a:off x="1354931" y="3494881"/>
                <a:ext cx="8890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altLang="en-US" sz="100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ercentage %</a:t>
                </a: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0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e</dc:creator>
  <cp:lastModifiedBy>DEEMA MOHAMAD *************** HUSSAIN</cp:lastModifiedBy>
  <cp:revision>2</cp:revision>
  <dcterms:created xsi:type="dcterms:W3CDTF">2016-11-21T17:44:32Z</dcterms:created>
  <dcterms:modified xsi:type="dcterms:W3CDTF">2017-05-04T13:35:24Z</dcterms:modified>
</cp:coreProperties>
</file>